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00B7A3-487A-48FB-8441-D91693537C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EB008-B9B5-4232-B050-FB287C6207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B1937F-D983-43BD-95BB-53F35A34DD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E73FE7-0FB4-41F3-864B-22BF8335AE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E12D3F-8CD5-452A-8BEE-1F8EBC3E32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B5F7C3-11A9-4095-9D1F-0A0D58ABA8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FF030C-6148-4EE3-8B39-413A5BA9E9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79320F-1083-48A1-A7B1-0ABEDB7B50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2A6A9C-DD84-4877-B1CF-E2DD9BEED5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5AE97D-3157-4F1E-A6E4-4D47911247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2AF008-702C-494D-9E4A-05520D2518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6C5BEA-4A46-475E-A4DB-A7DCCF2A37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9C737C-645C-42D7-B967-3383C0B2ACD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1447920" y="320040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7"/>
          <p:cNvSpPr/>
          <p:nvPr/>
        </p:nvSpPr>
        <p:spPr>
          <a:xfrm>
            <a:off x="1523880" y="3809880"/>
            <a:ext cx="64771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9: Venn diagram of  contigs obtained after BLASTX in NCBI-NR,TAIR and BLASTN for Cotton EST database. Contigs of (a) Drought tolerant genotype (GujCot-21) (b) Sensitive genotype (RAHS-IPS-187) (c) Super contig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3"/>
          <p:cNvSpPr/>
          <p:nvPr/>
        </p:nvSpPr>
        <p:spPr>
          <a:xfrm>
            <a:off x="7391520" y="304812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3"/>
          <p:cNvSpPr/>
          <p:nvPr/>
        </p:nvSpPr>
        <p:spPr>
          <a:xfrm>
            <a:off x="4267080" y="312408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11" descr=""/>
          <p:cNvPicPr/>
          <p:nvPr/>
        </p:nvPicPr>
        <p:blipFill>
          <a:blip r:embed="rId1"/>
          <a:srcRect l="9674" t="6056" r="9674" b="6056"/>
          <a:stretch/>
        </p:blipFill>
        <p:spPr>
          <a:xfrm>
            <a:off x="533520" y="838080"/>
            <a:ext cx="2209680" cy="221004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4" descr=""/>
          <p:cNvPicPr/>
          <p:nvPr/>
        </p:nvPicPr>
        <p:blipFill>
          <a:blip r:embed="rId2"/>
          <a:srcRect l="10279" t="6450" r="10430" b="6450"/>
          <a:stretch/>
        </p:blipFill>
        <p:spPr>
          <a:xfrm>
            <a:off x="3200400" y="838080"/>
            <a:ext cx="2362320" cy="22860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17" descr=""/>
          <p:cNvPicPr/>
          <p:nvPr/>
        </p:nvPicPr>
        <p:blipFill>
          <a:blip r:embed="rId3"/>
          <a:srcRect l="11101" t="7036" r="11240" b="7036"/>
          <a:stretch/>
        </p:blipFill>
        <p:spPr>
          <a:xfrm>
            <a:off x="6172200" y="914400"/>
            <a:ext cx="2209680" cy="2133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20T07:14:04Z</dcterms:created>
  <dc:creator>lab m</dc:creator>
  <dc:description/>
  <dc:language>en-US</dc:language>
  <cp:lastModifiedBy>neha</cp:lastModifiedBy>
  <dcterms:modified xsi:type="dcterms:W3CDTF">2012-10-23T07:16:44Z</dcterms:modified>
  <cp:revision>8</cp:revision>
  <dc:subject/>
  <dc:title>Slide 1</dc:title>
</cp:coreProperties>
</file>